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158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541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93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620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396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072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816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895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211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494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324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A95A3-B464-0E4D-BB8C-DF703C05E02D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A551-4549-E248-83CB-1E1B85EEC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899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49375" y="1151919"/>
            <a:ext cx="5996480" cy="4662823"/>
            <a:chOff x="0" y="0"/>
            <a:chExt cx="9028124" cy="6658612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biLevel thresh="50000"/>
            </a:blip>
            <a:srcRect l="2553" t="8450" r="32622" b="5634"/>
            <a:stretch/>
          </p:blipFill>
          <p:spPr bwMode="auto">
            <a:xfrm>
              <a:off x="0" y="0"/>
              <a:ext cx="8819445" cy="657498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ffectLst/>
          </p:spPr>
        </p:pic>
        <p:grpSp>
          <p:nvGrpSpPr>
            <p:cNvPr id="6" name="Group 5"/>
            <p:cNvGrpSpPr/>
            <p:nvPr/>
          </p:nvGrpSpPr>
          <p:grpSpPr>
            <a:xfrm>
              <a:off x="1449667" y="1727677"/>
              <a:ext cx="1905720" cy="1799005"/>
              <a:chOff x="1449667" y="1727677"/>
              <a:chExt cx="1905720" cy="1799005"/>
            </a:xfrm>
          </p:grpSpPr>
          <p:sp>
            <p:nvSpPr>
              <p:cNvPr id="31" name="Rectangle 30"/>
              <p:cNvSpPr/>
              <p:nvPr/>
            </p:nvSpPr>
            <p:spPr>
              <a:xfrm>
                <a:off x="1449667" y="1740732"/>
                <a:ext cx="1905720" cy="1785950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spcAft>
                    <a:spcPts val="0"/>
                  </a:spcAft>
                </a:pPr>
                <a:r>
                  <a:rPr lang="en-US" sz="13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sp>
            <p:nvSpPr>
              <p:cNvPr id="32" name="Text Box 34"/>
              <p:cNvSpPr txBox="1"/>
              <p:nvPr/>
            </p:nvSpPr>
            <p:spPr>
              <a:xfrm>
                <a:off x="1618536" y="1727677"/>
                <a:ext cx="1470264" cy="417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Beijing CC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1906677" y="3600400"/>
              <a:ext cx="1918755" cy="1928826"/>
              <a:chOff x="1906677" y="3600400"/>
              <a:chExt cx="1918755" cy="1928826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1906677" y="3600400"/>
                <a:ext cx="1643074" cy="1928826"/>
              </a:xfrm>
              <a:prstGeom prst="rect">
                <a:avLst/>
              </a:prstGeom>
              <a:noFill/>
              <a:ln w="12700" cmpd="sng">
                <a:solidFill>
                  <a:schemeClr val="tx1"/>
                </a:solidFill>
                <a:prstDash val="lgDashDot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spcAft>
                    <a:spcPts val="0"/>
                  </a:spcAft>
                </a:pPr>
                <a:r>
                  <a:rPr lang="en-US" sz="13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sp>
            <p:nvSpPr>
              <p:cNvPr id="30" name="Text Box 32"/>
              <p:cNvSpPr txBox="1"/>
              <p:nvPr/>
            </p:nvSpPr>
            <p:spPr>
              <a:xfrm>
                <a:off x="1978551" y="5108222"/>
                <a:ext cx="1846881" cy="4175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Delhi/CAS CC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3676999" y="2597988"/>
              <a:ext cx="3029104" cy="3954740"/>
              <a:chOff x="3676999" y="2597988"/>
              <a:chExt cx="3029104" cy="3954740"/>
            </a:xfrm>
          </p:grpSpPr>
          <p:sp>
            <p:nvSpPr>
              <p:cNvPr id="25" name="Text Box 27"/>
              <p:cNvSpPr txBox="1"/>
              <p:nvPr/>
            </p:nvSpPr>
            <p:spPr>
              <a:xfrm>
                <a:off x="3757309" y="4446358"/>
                <a:ext cx="2948794" cy="4175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East African Indian CC1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3855452" y="2597988"/>
                <a:ext cx="1385219" cy="786388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spcAft>
                    <a:spcPts val="0"/>
                  </a:spcAft>
                </a:pPr>
                <a:r>
                  <a:rPr lang="en-US" sz="13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3676999" y="3740996"/>
                <a:ext cx="2893098" cy="1071570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spcAft>
                    <a:spcPts val="0"/>
                  </a:spcAft>
                </a:pPr>
                <a:r>
                  <a:rPr lang="en-US" sz="13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3926891" y="4896544"/>
                <a:ext cx="1428760" cy="1656184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spcAft>
                    <a:spcPts val="0"/>
                  </a:spcAft>
                </a:pPr>
                <a:r>
                  <a:rPr lang="en-US" sz="13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</p:grpSp>
        <p:sp>
          <p:nvSpPr>
            <p:cNvPr id="9" name="Text Box 25"/>
            <p:cNvSpPr txBox="1"/>
            <p:nvPr/>
          </p:nvSpPr>
          <p:spPr>
            <a:xfrm>
              <a:off x="131762" y="694274"/>
              <a:ext cx="1951424" cy="4175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300" b="1" kern="1200">
                  <a:solidFill>
                    <a:srgbClr val="000000"/>
                  </a:solidFill>
                  <a:effectLst/>
                  <a:latin typeface="Times New Roman"/>
                  <a:ea typeface="Times New Roman"/>
                  <a:cs typeface="Times New Roman"/>
                </a:rPr>
                <a:t>S/Lineage 4 CC</a:t>
              </a:r>
              <a:endParaRPr lang="en-AU" sz="1300">
                <a:effectLst/>
                <a:latin typeface="Times New Roman"/>
                <a:ea typeface="Times New Roman"/>
                <a:cs typeface="Times New Roman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3634624" y="1583700"/>
              <a:ext cx="2564822" cy="936580"/>
              <a:chOff x="3634624" y="1583700"/>
              <a:chExt cx="2564822" cy="936580"/>
            </a:xfrm>
          </p:grpSpPr>
          <p:sp>
            <p:nvSpPr>
              <p:cNvPr id="23" name="Rectangle 22"/>
              <p:cNvSpPr/>
              <p:nvPr/>
            </p:nvSpPr>
            <p:spPr>
              <a:xfrm>
                <a:off x="3885681" y="1944216"/>
                <a:ext cx="829308" cy="576064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spcAft>
                    <a:spcPts val="0"/>
                  </a:spcAft>
                </a:pPr>
                <a:r>
                  <a:rPr lang="en-US" sz="1300">
                    <a:effectLst/>
                    <a:latin typeface="Times New Roman"/>
                    <a:ea typeface="Times New Roman"/>
                    <a:cs typeface="Times New Roman"/>
                  </a:rPr>
                  <a:t> 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sp>
            <p:nvSpPr>
              <p:cNvPr id="24" name="Text Box 24"/>
              <p:cNvSpPr txBox="1"/>
              <p:nvPr/>
            </p:nvSpPr>
            <p:spPr>
              <a:xfrm>
                <a:off x="3634624" y="1583700"/>
                <a:ext cx="2564822" cy="417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H37Rv/Lineage 4 CC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</p:grpSp>
        <p:sp>
          <p:nvSpPr>
            <p:cNvPr id="11" name="Text Box 22"/>
            <p:cNvSpPr txBox="1"/>
            <p:nvPr/>
          </p:nvSpPr>
          <p:spPr>
            <a:xfrm>
              <a:off x="6269247" y="502995"/>
              <a:ext cx="2397409" cy="4175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300" b="1" kern="1200">
                  <a:solidFill>
                    <a:srgbClr val="000000"/>
                  </a:solidFill>
                  <a:effectLst/>
                  <a:latin typeface="Times New Roman"/>
                  <a:ea typeface="Times New Roman"/>
                  <a:cs typeface="Times New Roman"/>
                </a:rPr>
                <a:t>LAM/Lineage 4 CC</a:t>
              </a:r>
              <a:endParaRPr lang="en-AU" sz="1300">
                <a:effectLst/>
                <a:latin typeface="Times New Roman"/>
                <a:ea typeface="Times New Roman"/>
                <a:cs typeface="Times New Roman"/>
              </a:endParaRP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6052488" y="5088184"/>
              <a:ext cx="2975636" cy="1570101"/>
              <a:chOff x="6052488" y="5088184"/>
              <a:chExt cx="2975636" cy="1570101"/>
            </a:xfrm>
          </p:grpSpPr>
          <p:cxnSp>
            <p:nvCxnSpPr>
              <p:cNvPr id="15" name="Straight Connector 14"/>
              <p:cNvCxnSpPr/>
              <p:nvPr/>
            </p:nvCxnSpPr>
            <p:spPr>
              <a:xfrm>
                <a:off x="6060979" y="5666968"/>
                <a:ext cx="560805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 Box 13"/>
              <p:cNvSpPr txBox="1"/>
              <p:nvPr/>
            </p:nvSpPr>
            <p:spPr>
              <a:xfrm>
                <a:off x="6634776" y="5475708"/>
                <a:ext cx="1044991" cy="4175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Beijing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>
                <a:off x="6052488" y="5279469"/>
                <a:ext cx="560805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  <a:prstDash val="sys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 Box 15"/>
              <p:cNvSpPr txBox="1"/>
              <p:nvPr/>
            </p:nvSpPr>
            <p:spPr>
              <a:xfrm>
                <a:off x="6626274" y="5088184"/>
                <a:ext cx="2401850" cy="4175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East African Indian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6060979" y="6049488"/>
                <a:ext cx="560805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  <a:prstDash val="lgDashDot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 Box 17"/>
              <p:cNvSpPr txBox="1"/>
              <p:nvPr/>
            </p:nvSpPr>
            <p:spPr>
              <a:xfrm>
                <a:off x="6634777" y="5858228"/>
                <a:ext cx="1421610" cy="4175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Delhi/CAS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6060979" y="6432008"/>
                <a:ext cx="560805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  <a:prstDash val="lgDash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 Box 19"/>
              <p:cNvSpPr txBox="1"/>
              <p:nvPr/>
            </p:nvSpPr>
            <p:spPr>
              <a:xfrm>
                <a:off x="6634777" y="6240749"/>
                <a:ext cx="2139549" cy="4175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300" b="1" kern="1200">
                    <a:solidFill>
                      <a:srgbClr val="000000"/>
                    </a:solidFill>
                    <a:effectLst/>
                    <a:latin typeface="Times New Roman"/>
                    <a:ea typeface="Times New Roman"/>
                    <a:cs typeface="Times New Roman"/>
                  </a:rPr>
                  <a:t>H37Rv/Lineage 4</a:t>
                </a:r>
                <a:endParaRPr lang="en-AU" sz="1300">
                  <a:effectLst/>
                  <a:latin typeface="Times New Roman"/>
                  <a:ea typeface="Times New Roman"/>
                  <a:cs typeface="Times New Roman"/>
                </a:endParaRPr>
              </a:p>
            </p:txBody>
          </p:sp>
        </p:grpSp>
        <p:sp>
          <p:nvSpPr>
            <p:cNvPr id="13" name="Text Box 10"/>
            <p:cNvSpPr txBox="1"/>
            <p:nvPr/>
          </p:nvSpPr>
          <p:spPr>
            <a:xfrm>
              <a:off x="2809472" y="6241076"/>
              <a:ext cx="2948794" cy="4175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300" b="1" kern="1200">
                  <a:solidFill>
                    <a:srgbClr val="000000"/>
                  </a:solidFill>
                  <a:effectLst/>
                  <a:latin typeface="Times New Roman"/>
                  <a:ea typeface="Times New Roman"/>
                  <a:cs typeface="Times New Roman"/>
                </a:rPr>
                <a:t>East African Indian CC2</a:t>
              </a:r>
              <a:endParaRPr lang="en-AU" sz="1300">
                <a:effectLst/>
                <a:latin typeface="Times New Roman"/>
                <a:ea typeface="Times New Roman"/>
                <a:cs typeface="Times New Roman"/>
              </a:endParaRPr>
            </a:p>
          </p:txBody>
        </p:sp>
        <p:sp>
          <p:nvSpPr>
            <p:cNvPr id="14" name="Text Box 11"/>
            <p:cNvSpPr txBox="1"/>
            <p:nvPr/>
          </p:nvSpPr>
          <p:spPr>
            <a:xfrm>
              <a:off x="3765796" y="2989483"/>
              <a:ext cx="2948794" cy="4175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300" b="1" kern="1200">
                  <a:solidFill>
                    <a:srgbClr val="000000"/>
                  </a:solidFill>
                  <a:effectLst/>
                  <a:latin typeface="Times New Roman"/>
                  <a:ea typeface="Times New Roman"/>
                  <a:cs typeface="Times New Roman"/>
                </a:rPr>
                <a:t>East African Indian CC3</a:t>
              </a:r>
              <a:endParaRPr lang="en-AU" sz="1300">
                <a:effectLst/>
                <a:latin typeface="Times New Roman"/>
                <a:ea typeface="Times New Roman"/>
                <a:cs typeface="Times New Roman"/>
              </a:endParaRPr>
            </a:p>
          </p:txBody>
        </p:sp>
      </p:grpSp>
      <p:sp>
        <p:nvSpPr>
          <p:cNvPr id="33" name="Rectangle 32"/>
          <p:cNvSpPr/>
          <p:nvPr/>
        </p:nvSpPr>
        <p:spPr>
          <a:xfrm>
            <a:off x="803078" y="177712"/>
            <a:ext cx="802342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S3 Fig. </a:t>
            </a:r>
            <a:r>
              <a:rPr lang="en-US" dirty="0">
                <a:latin typeface="Times New Roman"/>
                <a:cs typeface="Times New Roman"/>
              </a:rPr>
              <a:t>Minimum spanning tree of all culture-confirmed and MIRU-24 typed </a:t>
            </a:r>
            <a:r>
              <a:rPr lang="en-US" i="1" dirty="0">
                <a:latin typeface="Times New Roman"/>
                <a:cs typeface="Times New Roman"/>
              </a:rPr>
              <a:t>M. tuberculosis</a:t>
            </a:r>
            <a:r>
              <a:rPr lang="en-US" dirty="0">
                <a:latin typeface="Times New Roman"/>
                <a:cs typeface="Times New Roman"/>
              </a:rPr>
              <a:t> isolates identified between 2009-2013 in NSW, Australia</a:t>
            </a:r>
            <a:endParaRPr lang="en-AU" dirty="0">
              <a:latin typeface="Times New Roman"/>
              <a:cs typeface="Times New Roman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523875" y="6039961"/>
            <a:ext cx="76835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/>
                <a:cs typeface="Times New Roman"/>
              </a:rPr>
              <a:t>Boxes show different strain lineage clonal complexes (CC); Beijing lineage is represented by one CC, East African Indian has 3 CCs, Delhi-CAS has 1 CC, H37Rv like 1 CC, Haarlem 1 CC, LAM 1 CC;</a:t>
            </a:r>
            <a:endParaRPr lang="en-AU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536522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67578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9</Words>
  <Application>Microsoft Macintosh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ziijargal Gurjav</dc:creator>
  <cp:lastModifiedBy>Ulziijargal Gurjav</cp:lastModifiedBy>
  <cp:revision>1</cp:revision>
  <dcterms:created xsi:type="dcterms:W3CDTF">2016-09-24T07:00:10Z</dcterms:created>
  <dcterms:modified xsi:type="dcterms:W3CDTF">2016-09-24T07:02:24Z</dcterms:modified>
</cp:coreProperties>
</file>